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2" r:id="rId2"/>
    <p:sldId id="275" r:id="rId3"/>
    <p:sldId id="282" r:id="rId4"/>
    <p:sldId id="283" r:id="rId5"/>
  </p:sldIdLst>
  <p:sldSz cx="9144000" cy="6858000" type="screen4x3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750" autoAdjust="0"/>
  </p:normalViewPr>
  <p:slideViewPr>
    <p:cSldViewPr>
      <p:cViewPr varScale="1">
        <p:scale>
          <a:sx n="122" d="100"/>
          <a:sy n="122" d="100"/>
        </p:scale>
        <p:origin x="103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AB7FCB-AB7C-4EE2-A344-BC01E99725FF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54075" y="744538"/>
            <a:ext cx="49609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716463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0AF5C-3587-441B-AE28-C558EF897B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07996-2142-4FC0-96A7-0810877CDDCD}" type="datetimeFigureOut">
              <a:rPr lang="en-US" smtClean="0"/>
              <a:pPr/>
              <a:t>9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D9EF9-7453-4A63-AD56-36289C05F22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Rectangle 1"/>
          <p:cNvSpPr>
            <a:spLocks noChangeArrowheads="1"/>
          </p:cNvSpPr>
          <p:nvPr/>
        </p:nvSpPr>
        <p:spPr bwMode="auto">
          <a:xfrm>
            <a:off x="231379" y="5373216"/>
            <a:ext cx="8286808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alysis of metagene 16S rRNA 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of bacteria digested with </a:t>
            </a:r>
            <a:r>
              <a:rPr kumimoji="0" lang="en-US" sz="14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Mbo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I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in stool samples collected from 30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healthy children by RFLP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(A), and cluster analysis of RFLP fingerprints (B).  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H01-H30: 30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samples from 30 children, M: 100 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bp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DNA marker (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Intron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, Korea). HV1-HV10: gut viral groups of healthy children</a:t>
            </a:r>
            <a:endParaRPr kumimoji="0" 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4282" y="214290"/>
            <a:ext cx="414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3BC156E-B8D2-8F91-9F74-5606C3AD114B}"/>
              </a:ext>
            </a:extLst>
          </p:cNvPr>
          <p:cNvGrpSpPr/>
          <p:nvPr/>
        </p:nvGrpSpPr>
        <p:grpSpPr>
          <a:xfrm>
            <a:off x="214282" y="709960"/>
            <a:ext cx="8929718" cy="4672548"/>
            <a:chOff x="214282" y="709960"/>
            <a:chExt cx="8929718" cy="4672548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85720" y="709960"/>
              <a:ext cx="4071966" cy="20046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14282" y="2786058"/>
              <a:ext cx="4214842" cy="20997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4"/>
            <a:srcRect r="6577" b="2939"/>
            <a:stretch>
              <a:fillRect/>
            </a:stretch>
          </p:blipFill>
          <p:spPr bwMode="auto">
            <a:xfrm>
              <a:off x="4429092" y="714356"/>
              <a:ext cx="4714908" cy="4146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3C3F364-169A-48F3-6522-F12AD3C8E5CE}"/>
                </a:ext>
              </a:extLst>
            </p:cNvPr>
            <p:cNvSpPr txBox="1"/>
            <p:nvPr/>
          </p:nvSpPr>
          <p:spPr>
            <a:xfrm>
              <a:off x="214282" y="5013176"/>
              <a:ext cx="565386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A                                                                               B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42844" y="5286388"/>
            <a:ext cx="8572560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Analysis of V3 region in 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metagene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16S 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rRNA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of bacteria in fecal samples collected from  30 persistent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diarrheal children by DGGE (A), and cluster analysis of fingerprints of DGGE  (B).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P01-P31: diarrheal samples; PV1-PV10</a:t>
            </a:r>
            <a:r>
              <a:rPr lang="en-US" sz="1400" dirty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Arial" pitchFamily="34" charset="0"/>
              </a:rPr>
              <a:t>: gut viral groups of persistent diarrhea children</a:t>
            </a:r>
            <a:r>
              <a:rPr kumimoji="0" lang="en-US" sz="14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.</a:t>
            </a:r>
            <a:endParaRPr kumimoji="0" 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4282" y="71414"/>
            <a:ext cx="414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BC8447A-449E-47A7-E2A4-CF27488818C1}"/>
              </a:ext>
            </a:extLst>
          </p:cNvPr>
          <p:cNvGrpSpPr/>
          <p:nvPr/>
        </p:nvGrpSpPr>
        <p:grpSpPr>
          <a:xfrm>
            <a:off x="142844" y="428604"/>
            <a:ext cx="8937476" cy="4817703"/>
            <a:chOff x="142844" y="428604"/>
            <a:chExt cx="8937476" cy="4817703"/>
          </a:xfrm>
        </p:grpSpPr>
        <p:pic>
          <p:nvPicPr>
            <p:cNvPr id="3379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42844" y="428604"/>
              <a:ext cx="3435359" cy="21320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3795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42845" y="2643182"/>
              <a:ext cx="3357586" cy="22714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3796" name="Picture 4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3388351" y="469244"/>
              <a:ext cx="5691969" cy="44291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97A12EB-6E31-4655-9A22-7999FEC720BF}"/>
                </a:ext>
              </a:extLst>
            </p:cNvPr>
            <p:cNvSpPr txBox="1"/>
            <p:nvPr/>
          </p:nvSpPr>
          <p:spPr>
            <a:xfrm>
              <a:off x="214282" y="4876975"/>
              <a:ext cx="565386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A                                                           B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81001" y="228601"/>
            <a:ext cx="2514600" cy="341539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r>
              <a:rPr lang="en-US" dirty="0"/>
              <a:t>Figure S3.</a:t>
            </a:r>
          </a:p>
        </p:txBody>
      </p:sp>
      <p:sp>
        <p:nvSpPr>
          <p:cNvPr id="4" name="Rectangle 3"/>
          <p:cNvSpPr/>
          <p:nvPr/>
        </p:nvSpPr>
        <p:spPr>
          <a:xfrm>
            <a:off x="357158" y="5643578"/>
            <a:ext cx="792961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Palatino Linotype" pitchFamily="18" charset="0"/>
                <a:cs typeface="Arial" pitchFamily="34" charset="0"/>
              </a:rPr>
              <a:t>Diversity (A) and Pearson correlation of genus abundances (B) of the viral genera from samples extracted by different processes. </a:t>
            </a:r>
            <a:r>
              <a:rPr lang="en-GB" sz="1400" dirty="0">
                <a:latin typeface="Palatino Linotype" pitchFamily="18" charset="0"/>
                <a:cs typeface="Arial" pitchFamily="34" charset="0"/>
              </a:rPr>
              <a:t>P1-P5, P7: processes used for extraction of viral </a:t>
            </a:r>
            <a:r>
              <a:rPr lang="en-GB" sz="1400" dirty="0" err="1">
                <a:latin typeface="Palatino Linotype" pitchFamily="18" charset="0"/>
                <a:cs typeface="Arial" pitchFamily="34" charset="0"/>
              </a:rPr>
              <a:t>metagenome</a:t>
            </a:r>
            <a:r>
              <a:rPr lang="en-GB" sz="1400" dirty="0">
                <a:latin typeface="Palatino Linotype" pitchFamily="18" charset="0"/>
                <a:cs typeface="Arial" pitchFamily="34" charset="0"/>
              </a:rPr>
              <a:t>.</a:t>
            </a:r>
            <a:endParaRPr lang="en-US" sz="1400" dirty="0">
              <a:latin typeface="Palatino Linotype" pitchFamily="18" charset="0"/>
              <a:cs typeface="Arial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7567554-EF16-878B-BF44-897C36388A1F}"/>
              </a:ext>
            </a:extLst>
          </p:cNvPr>
          <p:cNvGrpSpPr/>
          <p:nvPr/>
        </p:nvGrpSpPr>
        <p:grpSpPr>
          <a:xfrm>
            <a:off x="45440" y="1034143"/>
            <a:ext cx="8746560" cy="4626428"/>
            <a:chOff x="45440" y="1034143"/>
            <a:chExt cx="8746560" cy="4626428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5440" y="1034143"/>
              <a:ext cx="8746560" cy="46264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F82656D-8000-6A5C-D512-3B050AE343C6}"/>
                </a:ext>
              </a:extLst>
            </p:cNvPr>
            <p:cNvSpPr txBox="1"/>
            <p:nvPr/>
          </p:nvSpPr>
          <p:spPr>
            <a:xfrm>
              <a:off x="179512" y="5291239"/>
              <a:ext cx="651795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A                                                                                                                    B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6"/>
          <p:cNvSpPr txBox="1"/>
          <p:nvPr/>
        </p:nvSpPr>
        <p:spPr>
          <a:xfrm>
            <a:off x="76201" y="76201"/>
            <a:ext cx="2514600" cy="341539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r>
              <a:rPr lang="en-US"/>
              <a:t>Figure S4.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428596" y="5380672"/>
            <a:ext cx="821537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Palatino Linotype" pitchFamily="18" charset="0"/>
              </a:rPr>
              <a:t>Diversity (A) and Pearson correlation of species abundances (B) of the viral species from samples extracted by different processes. </a:t>
            </a:r>
            <a:r>
              <a:rPr lang="en-GB" sz="1400" dirty="0">
                <a:latin typeface="Palatino Linotype" pitchFamily="18" charset="0"/>
              </a:rPr>
              <a:t>P1-P5, P7: processes used for extraction of viral </a:t>
            </a:r>
            <a:r>
              <a:rPr lang="en-GB" sz="1400" dirty="0" err="1">
                <a:latin typeface="Palatino Linotype" pitchFamily="18" charset="0"/>
              </a:rPr>
              <a:t>metagenome</a:t>
            </a:r>
            <a:endParaRPr lang="en-US" sz="1400" dirty="0">
              <a:latin typeface="Palatino Linotype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AD15DD8-82AD-8F1E-3179-08ABAC875CCF}"/>
              </a:ext>
            </a:extLst>
          </p:cNvPr>
          <p:cNvGrpSpPr/>
          <p:nvPr/>
        </p:nvGrpSpPr>
        <p:grpSpPr>
          <a:xfrm>
            <a:off x="105432" y="1088571"/>
            <a:ext cx="8799921" cy="4354286"/>
            <a:chOff x="105432" y="1088571"/>
            <a:chExt cx="8799921" cy="4354286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05432" y="1088571"/>
              <a:ext cx="8799921" cy="43542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644C54C-3450-832E-1491-D920C6376CD3}"/>
                </a:ext>
              </a:extLst>
            </p:cNvPr>
            <p:cNvSpPr txBox="1"/>
            <p:nvPr/>
          </p:nvSpPr>
          <p:spPr>
            <a:xfrm>
              <a:off x="107504" y="5124259"/>
              <a:ext cx="65179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dirty="0"/>
                <a:t>A                                                                                                            B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1</TotalTime>
  <Words>199</Words>
  <Application>Microsoft Office PowerPoint</Application>
  <PresentationFormat>On-screen Show (4:3)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H D</cp:lastModifiedBy>
  <cp:revision>58</cp:revision>
  <dcterms:created xsi:type="dcterms:W3CDTF">2024-12-23T02:32:54Z</dcterms:created>
  <dcterms:modified xsi:type="dcterms:W3CDTF">2025-09-27T15:51:52Z</dcterms:modified>
</cp:coreProperties>
</file>